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59" autoAdjust="0"/>
    <p:restoredTop sz="94660"/>
  </p:normalViewPr>
  <p:slideViewPr>
    <p:cSldViewPr snapToGrid="0">
      <p:cViewPr varScale="1">
        <p:scale>
          <a:sx n="91" d="100"/>
          <a:sy n="91" d="100"/>
        </p:scale>
        <p:origin x="74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D8988-A9FB-47A7-9207-09A3D77B195C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D90E2-8B7F-4BAA-B263-A29FA9BA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54020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D8988-A9FB-47A7-9207-09A3D77B195C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D90E2-8B7F-4BAA-B263-A29FA9BA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679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D8988-A9FB-47A7-9207-09A3D77B195C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D90E2-8B7F-4BAA-B263-A29FA9BA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1349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D8988-A9FB-47A7-9207-09A3D77B195C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D90E2-8B7F-4BAA-B263-A29FA9BA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19224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D8988-A9FB-47A7-9207-09A3D77B195C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D90E2-8B7F-4BAA-B263-A29FA9BA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3249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D8988-A9FB-47A7-9207-09A3D77B195C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D90E2-8B7F-4BAA-B263-A29FA9BA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36962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D8988-A9FB-47A7-9207-09A3D77B195C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D90E2-8B7F-4BAA-B263-A29FA9BA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45981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D8988-A9FB-47A7-9207-09A3D77B195C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D90E2-8B7F-4BAA-B263-A29FA9BA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6207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D8988-A9FB-47A7-9207-09A3D77B195C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D90E2-8B7F-4BAA-B263-A29FA9BA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3037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D8988-A9FB-47A7-9207-09A3D77B195C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D90E2-8B7F-4BAA-B263-A29FA9BA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010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D8988-A9FB-47A7-9207-09A3D77B195C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D90E2-8B7F-4BAA-B263-A29FA9BA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9049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7D8988-A9FB-47A7-9207-09A3D77B195C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4D90E2-8B7F-4BAA-B263-A29FA9BA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0833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12501413"/>
              </p:ext>
            </p:extLst>
          </p:nvPr>
        </p:nvGraphicFramePr>
        <p:xfrm>
          <a:off x="153760" y="771261"/>
          <a:ext cx="7737208" cy="3669248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461566"/>
                <a:gridCol w="1252771"/>
                <a:gridCol w="1252771"/>
                <a:gridCol w="1043976"/>
                <a:gridCol w="1539587"/>
                <a:gridCol w="1186537"/>
              </a:tblGrid>
              <a:tr h="532686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 err="1">
                          <a:effectLst/>
                        </a:rPr>
                        <a:t>P</a:t>
                      </a:r>
                      <a:r>
                        <a:rPr lang="en-US" sz="1400" b="1" u="none" strike="noStrike" dirty="0" err="1" smtClean="0">
                          <a:effectLst/>
                        </a:rPr>
                        <a:t>robeID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BETA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S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P_VAL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FDR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 smtClean="0">
                          <a:effectLst/>
                        </a:rPr>
                        <a:t>Nearest gen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53741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g0307114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-0.2872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0.04802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2.23E-0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0.00104615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ASB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493459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g0461621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0.10115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1871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6.51E-0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0.01530186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dirty="0" smtClean="0">
                          <a:effectLst/>
                        </a:rPr>
                        <a:t>BOLA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53741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g0130711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-0.1951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0.03745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1.88E-0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0.02943826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dirty="0" smtClean="0">
                          <a:effectLst/>
                        </a:rPr>
                        <a:t>YDJC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53741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g1189864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-0.1646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3237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3.68E-0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3794861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dirty="0" smtClean="0">
                          <a:effectLst/>
                        </a:rPr>
                        <a:t>EBF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53741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g0675507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-0.1966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0.03886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4.20E-0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3794861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dirty="0" smtClean="0">
                          <a:effectLst/>
                        </a:rPr>
                        <a:t>TRPV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493459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g0834417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12391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2462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4.85E-0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3794861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dirty="0" smtClean="0">
                          <a:effectLst/>
                        </a:rPr>
                        <a:t>FAM50B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87084" y="185057"/>
            <a:ext cx="913311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/>
              <a:t>Supplementary file S6</a:t>
            </a:r>
            <a:r>
              <a:rPr lang="en-GB" sz="1600" b="1" dirty="0" smtClean="0"/>
              <a:t>. </a:t>
            </a:r>
            <a:r>
              <a:rPr lang="en-GB" sz="1600" b="1" dirty="0" smtClean="0"/>
              <a:t>List of significant DMPs (FDR &lt; 0.05) from the Recurrent vs Intermittent AF adjusted </a:t>
            </a:r>
            <a:r>
              <a:rPr lang="en-GB" sz="1600" b="1" smtClean="0"/>
              <a:t>model </a:t>
            </a:r>
            <a:endParaRPr lang="en-GB" sz="1600" b="1" dirty="0"/>
          </a:p>
        </p:txBody>
      </p:sp>
    </p:spTree>
    <p:extLst>
      <p:ext uri="{BB962C8B-B14F-4D97-AF65-F5344CB8AC3E}">
        <p14:creationId xmlns:p14="http://schemas.microsoft.com/office/powerpoint/2010/main" val="18673444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68</Words>
  <Application>Microsoft Macintosh PowerPoint</Application>
  <PresentationFormat>On-screen Show (4:3)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>IARC</Company>
  <LinksUpToDate>false</LinksUpToDate>
  <SharedDoc>false</SharedDoc>
  <HyperlinksChanged>false</HyperlinksChanged>
  <AppVersion>15.003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kram Ghantous</dc:creator>
  <cp:lastModifiedBy>Michael Routledge</cp:lastModifiedBy>
  <cp:revision>4</cp:revision>
  <dcterms:created xsi:type="dcterms:W3CDTF">2020-03-13T18:38:48Z</dcterms:created>
  <dcterms:modified xsi:type="dcterms:W3CDTF">2021-03-25T16:18:24Z</dcterms:modified>
</cp:coreProperties>
</file>